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56" r:id="rId3"/>
    <p:sldId id="257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33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 showGuides="1">
      <p:cViewPr>
        <p:scale>
          <a:sx n="153" d="100"/>
          <a:sy n="153" d="100"/>
        </p:scale>
        <p:origin x="528" y="-3328"/>
      </p:cViewPr>
      <p:guideLst>
        <p:guide orient="horz" pos="1033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DF890-647D-48EA-AFA8-E1E640CE5F9C}" type="datetimeFigureOut">
              <a:rPr lang="en-AU" smtClean="0"/>
              <a:t>23/11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0B14B-63E5-445E-BD38-02FAC19D057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16300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DF890-647D-48EA-AFA8-E1E640CE5F9C}" type="datetimeFigureOut">
              <a:rPr lang="en-AU" smtClean="0"/>
              <a:t>23/11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0B14B-63E5-445E-BD38-02FAC19D057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381549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DF890-647D-48EA-AFA8-E1E640CE5F9C}" type="datetimeFigureOut">
              <a:rPr lang="en-AU" smtClean="0"/>
              <a:t>23/11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0B14B-63E5-445E-BD38-02FAC19D057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63057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DF890-647D-48EA-AFA8-E1E640CE5F9C}" type="datetimeFigureOut">
              <a:rPr lang="en-AU" smtClean="0"/>
              <a:t>23/11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0B14B-63E5-445E-BD38-02FAC19D057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450029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DF890-647D-48EA-AFA8-E1E640CE5F9C}" type="datetimeFigureOut">
              <a:rPr lang="en-AU" smtClean="0"/>
              <a:t>23/11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0B14B-63E5-445E-BD38-02FAC19D057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840000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DF890-647D-48EA-AFA8-E1E640CE5F9C}" type="datetimeFigureOut">
              <a:rPr lang="en-AU" smtClean="0"/>
              <a:t>23/11/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0B14B-63E5-445E-BD38-02FAC19D057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976665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DF890-647D-48EA-AFA8-E1E640CE5F9C}" type="datetimeFigureOut">
              <a:rPr lang="en-AU" smtClean="0"/>
              <a:t>23/11/20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0B14B-63E5-445E-BD38-02FAC19D057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300590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DF890-647D-48EA-AFA8-E1E640CE5F9C}" type="datetimeFigureOut">
              <a:rPr lang="en-AU" smtClean="0"/>
              <a:t>23/11/20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0B14B-63E5-445E-BD38-02FAC19D057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365038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DF890-647D-48EA-AFA8-E1E640CE5F9C}" type="datetimeFigureOut">
              <a:rPr lang="en-AU" smtClean="0"/>
              <a:t>23/11/20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0B14B-63E5-445E-BD38-02FAC19D057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992695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DF890-647D-48EA-AFA8-E1E640CE5F9C}" type="datetimeFigureOut">
              <a:rPr lang="en-AU" smtClean="0"/>
              <a:t>23/11/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0B14B-63E5-445E-BD38-02FAC19D057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994807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DF890-647D-48EA-AFA8-E1E640CE5F9C}" type="datetimeFigureOut">
              <a:rPr lang="en-AU" smtClean="0"/>
              <a:t>23/11/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0B14B-63E5-445E-BD38-02FAC19D057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391918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DDF890-647D-48EA-AFA8-E1E640CE5F9C}" type="datetimeFigureOut">
              <a:rPr lang="en-AU" smtClean="0"/>
              <a:t>23/11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50B14B-63E5-445E-BD38-02FAC19D057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39891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F6F9E7AF-F4DE-2541-9DA9-7A3BF70E12D5}"/>
              </a:ext>
            </a:extLst>
          </p:cNvPr>
          <p:cNvSpPr/>
          <p:nvPr/>
        </p:nvSpPr>
        <p:spPr>
          <a:xfrm>
            <a:off x="248955" y="170569"/>
            <a:ext cx="3429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spcBef>
                <a:spcPts val="1200"/>
              </a:spcBef>
              <a:spcAft>
                <a:spcPts val="0"/>
              </a:spcAft>
            </a:pPr>
            <a:r>
              <a:rPr lang="en-GB" b="1" kern="0" dirty="0">
                <a:solidFill>
                  <a:srgbClr val="2F5496"/>
                </a:solidFill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orting information</a:t>
            </a:r>
            <a:endParaRPr lang="en-AU" b="1" kern="0" dirty="0">
              <a:solidFill>
                <a:srgbClr val="2F5496"/>
              </a:solidFill>
              <a:latin typeface="Calibri Light" panose="020F03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GB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: 1</a:t>
            </a:r>
            <a:r>
              <a:rPr lang="en-GB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AU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3" descr="A picture containing diagram&#10;&#10;Description automatically generated">
            <a:extLst>
              <a:ext uri="{FF2B5EF4-FFF2-40B4-BE49-F238E27FC236}">
                <a16:creationId xmlns:a16="http://schemas.microsoft.com/office/drawing/2014/main" id="{4417F8EC-660B-F545-9722-37EDBC8FF44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3223" y="816900"/>
            <a:ext cx="4871554" cy="783993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3">
            <a:extLst>
              <a:ext uri="{FF2B5EF4-FFF2-40B4-BE49-F238E27FC236}">
                <a16:creationId xmlns:a16="http://schemas.microsoft.com/office/drawing/2014/main" id="{375C34ED-C4A3-284F-AABE-89C7E2A96C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9027545"/>
            <a:ext cx="6858000" cy="7694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1</a:t>
            </a:r>
            <a:r>
              <a:rPr kumimoji="0" lang="en-AU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Immunocytochemistry of transfected CHO cells demonstrates antibody specificity.</a:t>
            </a:r>
            <a:endParaRPr kumimoji="0" lang="en-AU" altLang="en-US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lvl="0" algn="just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AU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inese hamster ovarian (CHO) cells transfected with plasmids containing either </a:t>
            </a:r>
            <a:r>
              <a:rPr kumimoji="0" lang="en-AU" altLang="en-US" sz="11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cnq1</a:t>
            </a:r>
            <a:r>
              <a:rPr kumimoji="0" lang="en-AU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kumimoji="0" lang="en-AU" altLang="en-U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kumimoji="0" lang="en-AU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, </a:t>
            </a:r>
            <a:r>
              <a:rPr kumimoji="0" lang="en-AU" altLang="en-US" sz="11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cnq4</a:t>
            </a:r>
            <a:r>
              <a:rPr kumimoji="0" lang="en-AU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kumimoji="0" lang="en-AU" altLang="en-U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kumimoji="0" lang="en-AU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or </a:t>
            </a:r>
            <a:r>
              <a:rPr kumimoji="0" lang="en-AU" altLang="en-US" sz="11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cnq5</a:t>
            </a:r>
            <a:r>
              <a:rPr kumimoji="0" lang="en-AU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kumimoji="0" lang="en-AU" altLang="en-U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</a:t>
            </a:r>
            <a:r>
              <a:rPr kumimoji="0" lang="en-AU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presented with diffuse labelling for K</a:t>
            </a:r>
            <a:r>
              <a:rPr kumimoji="0" lang="en-AU" altLang="en-US" sz="1100" b="0" i="0" u="none" strike="noStrike" cap="none" normalizeH="0" baseline="-25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</a:t>
            </a:r>
            <a:r>
              <a:rPr kumimoji="0" lang="en-AU" altLang="en-US" sz="1100" b="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7.1, K</a:t>
            </a:r>
            <a:r>
              <a:rPr kumimoji="0" lang="en-AU" altLang="en-US" sz="1100" b="0" i="0" u="none" strike="noStrike" cap="none" normalizeH="0" baseline="-25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</a:t>
            </a:r>
            <a:r>
              <a:rPr kumimoji="0" lang="en-AU" altLang="en-US" sz="1100" b="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7.4 and K</a:t>
            </a:r>
            <a:r>
              <a:rPr kumimoji="0" lang="en-AU" altLang="en-US" sz="1100" b="0" i="0" u="none" strike="noStrike" cap="none" normalizeH="0" baseline="-25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</a:t>
            </a:r>
            <a:r>
              <a:rPr kumimoji="0" lang="en-AU" altLang="en-US" sz="1100" b="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7.5 respectively. No staining was observed in</a:t>
            </a:r>
            <a:r>
              <a:rPr kumimoji="0" lang="en-AU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non-transfected CHO cells</a:t>
            </a:r>
            <a:r>
              <a:rPr kumimoji="0" lang="en-AU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kumimoji="0" lang="en-AU" altLang="en-U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kumimoji="0" lang="en-AU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</a:t>
            </a:r>
            <a:r>
              <a:rPr kumimoji="0" lang="en-AU" altLang="en-U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</a:t>
            </a:r>
            <a:r>
              <a:rPr kumimoji="0" lang="en-AU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</a:t>
            </a:r>
            <a:r>
              <a:rPr kumimoji="0" lang="en-AU" altLang="en-U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r>
              <a:rPr kumimoji="0" lang="en-AU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. </a:t>
            </a:r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4′,6-diamidino-2-phenylindole (DAPI; e.g. inset).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n-AU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kumimoji="0" lang="en-AU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66008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87A65730-3806-4B94-9374-51CBE8D07DE6}"/>
              </a:ext>
            </a:extLst>
          </p:cNvPr>
          <p:cNvSpPr/>
          <p:nvPr/>
        </p:nvSpPr>
        <p:spPr>
          <a:xfrm>
            <a:off x="248955" y="170569"/>
            <a:ext cx="3429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spcAft>
                <a:spcPts val="0"/>
              </a:spcAft>
            </a:pPr>
            <a:r>
              <a:rPr lang="en-GB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: 2</a:t>
            </a:r>
            <a:r>
              <a:rPr lang="en-GB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AU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75E6BBA-DB2F-41C7-8418-6C97EFD3B94A}"/>
              </a:ext>
            </a:extLst>
          </p:cNvPr>
          <p:cNvSpPr txBox="1"/>
          <p:nvPr/>
        </p:nvSpPr>
        <p:spPr>
          <a:xfrm>
            <a:off x="484906" y="1195209"/>
            <a:ext cx="15462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b="1" dirty="0"/>
              <a:t>Supplemental data 2.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B0217757-9437-4A2C-BE0D-6B631728B5C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485" y="1166169"/>
            <a:ext cx="6120000" cy="3751056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72003F6B-9FC3-471C-9F91-796BD1172D3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485" y="5260773"/>
            <a:ext cx="6120000" cy="3753783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65D27999-C393-4121-AEB4-B1161C421029}"/>
              </a:ext>
            </a:extLst>
          </p:cNvPr>
          <p:cNvSpPr txBox="1"/>
          <p:nvPr/>
        </p:nvSpPr>
        <p:spPr>
          <a:xfrm>
            <a:off x="287761" y="823555"/>
            <a:ext cx="19798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10 nm Au-7.4 in E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6F9EE4F-6979-42E2-B8BD-854FE7A98CFB}"/>
              </a:ext>
            </a:extLst>
          </p:cNvPr>
          <p:cNvSpPr txBox="1"/>
          <p:nvPr/>
        </p:nvSpPr>
        <p:spPr>
          <a:xfrm>
            <a:off x="276387" y="4933816"/>
            <a:ext cx="18628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5 nm Au-7.4 in EC</a:t>
            </a:r>
          </a:p>
        </p:txBody>
      </p:sp>
      <p:pic>
        <p:nvPicPr>
          <p:cNvPr id="21" name="Picture 20" descr="A picture containing indoor, sitting, snow, photo&#10;&#10;Description automatically generated">
            <a:extLst>
              <a:ext uri="{FF2B5EF4-FFF2-40B4-BE49-F238E27FC236}">
                <a16:creationId xmlns:a16="http://schemas.microsoft.com/office/drawing/2014/main" id="{54B8DE4A-E83D-431A-BD63-7B2769AD2F0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13614" y="1221972"/>
            <a:ext cx="1438590" cy="889344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786F72D8-F3BA-42F7-B71B-8AD664DA98D1}"/>
              </a:ext>
            </a:extLst>
          </p:cNvPr>
          <p:cNvCxnSpPr>
            <a:cxnSpLocks/>
          </p:cNvCxnSpPr>
          <p:nvPr/>
        </p:nvCxnSpPr>
        <p:spPr>
          <a:xfrm flipH="1" flipV="1">
            <a:off x="5780888" y="1830459"/>
            <a:ext cx="142822" cy="159622"/>
          </a:xfrm>
          <a:prstGeom prst="straightConnector1">
            <a:avLst/>
          </a:prstGeom>
          <a:ln w="12700">
            <a:solidFill>
              <a:schemeClr val="tx1"/>
            </a:solidFill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2DFD81F7-18D8-408E-B572-1C36DB9F2838}"/>
              </a:ext>
            </a:extLst>
          </p:cNvPr>
          <p:cNvCxnSpPr>
            <a:cxnSpLocks/>
          </p:cNvCxnSpPr>
          <p:nvPr/>
        </p:nvCxnSpPr>
        <p:spPr>
          <a:xfrm flipH="1" flipV="1">
            <a:off x="5528819" y="1975223"/>
            <a:ext cx="142822" cy="159622"/>
          </a:xfrm>
          <a:prstGeom prst="straightConnector1">
            <a:avLst/>
          </a:prstGeom>
          <a:ln w="12700">
            <a:solidFill>
              <a:schemeClr val="tx1"/>
            </a:solidFill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FC8150AA-E2A0-4EBE-AF4A-473AB31B3ECC}"/>
              </a:ext>
            </a:extLst>
          </p:cNvPr>
          <p:cNvCxnSpPr>
            <a:cxnSpLocks/>
          </p:cNvCxnSpPr>
          <p:nvPr/>
        </p:nvCxnSpPr>
        <p:spPr>
          <a:xfrm flipH="1" flipV="1">
            <a:off x="6176335" y="1723061"/>
            <a:ext cx="142822" cy="159622"/>
          </a:xfrm>
          <a:prstGeom prst="straightConnector1">
            <a:avLst/>
          </a:prstGeom>
          <a:ln w="12700">
            <a:solidFill>
              <a:schemeClr val="tx1"/>
            </a:solidFill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2AD37E07-736E-44AD-AA7D-9D2DA2C14B88}"/>
              </a:ext>
            </a:extLst>
          </p:cNvPr>
          <p:cNvCxnSpPr>
            <a:cxnSpLocks/>
          </p:cNvCxnSpPr>
          <p:nvPr/>
        </p:nvCxnSpPr>
        <p:spPr>
          <a:xfrm flipH="1" flipV="1">
            <a:off x="6336917" y="1562614"/>
            <a:ext cx="142822" cy="159622"/>
          </a:xfrm>
          <a:prstGeom prst="straightConnector1">
            <a:avLst/>
          </a:prstGeom>
          <a:ln w="12700">
            <a:solidFill>
              <a:schemeClr val="tx1"/>
            </a:solidFill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876845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FF4B2BC7-DA0E-4C6A-A607-36A65B4A8A22}"/>
              </a:ext>
            </a:extLst>
          </p:cNvPr>
          <p:cNvSpPr/>
          <p:nvPr/>
        </p:nvSpPr>
        <p:spPr>
          <a:xfrm>
            <a:off x="354843" y="5454488"/>
            <a:ext cx="6209730" cy="19543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AU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. Rat mesenteric artery endothelium (EC) ultrastructure, and distribution of Kv7.4 and 7.5.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In 3</a:t>
            </a:r>
            <a:r>
              <a:rPr lang="en-AU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rd</a:t>
            </a:r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 to 4</a:t>
            </a:r>
            <a:r>
              <a:rPr lang="en-AU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 order vessels, K</a:t>
            </a:r>
            <a:r>
              <a:rPr lang="en-AU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7.4 antibody conjugated to 5 and 10 nm Au was present in caveolae-rich densities near cell borders, as well as at golgi apparatus (</a:t>
            </a:r>
            <a:r>
              <a:rPr lang="en-AU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AU" sz="11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, with similar and predominant localization of Kv7.5-10 nm Au at or near caveolae (</a:t>
            </a:r>
            <a:r>
              <a:rPr lang="en-AU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) at cell borders. The potential caveolae-associated K</a:t>
            </a:r>
            <a:r>
              <a:rPr lang="en-AU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7.4 and 7.5 is present in a circular to omega-shaped pattern consistent with the distribution, size and structure of these organelles (e.g. typical caveolae morphology ~70 nm at widest point; e.g.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(Howitt 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et al.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, 2012;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Senadheera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et al.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, 2013; Grayson 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et al.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, 2013) </a:t>
            </a:r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from conventional transmission electron microscopy of rat mesenteric artery endothelium; insets, </a:t>
            </a:r>
            <a:r>
              <a:rPr lang="en-AU" sz="1100" b="1" dirty="0">
                <a:latin typeface="Arial" panose="020B0604020202020204" pitchFamily="34" charset="0"/>
                <a:cs typeface="Arial" panose="020B0604020202020204" pitchFamily="34" charset="0"/>
              </a:rPr>
              <a:t>A,C</a:t>
            </a:r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). Gold label over endothelial cell profiles was ~20-fold higher than equivalent lumen or internal elastic lamina (IEL) regions, with this latter label taken as background labelling. Bar, 0.2 µm. 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3493D0E-A5B2-451A-863A-1156B04BA6E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7239" y="889976"/>
            <a:ext cx="6120000" cy="455796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A6985CD-B9E7-4CA2-8CA6-F66F333C742B}"/>
              </a:ext>
            </a:extLst>
          </p:cNvPr>
          <p:cNvSpPr txBox="1"/>
          <p:nvPr/>
        </p:nvSpPr>
        <p:spPr>
          <a:xfrm>
            <a:off x="345006" y="530860"/>
            <a:ext cx="19798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10 nm Au-7.5 in EC</a:t>
            </a:r>
          </a:p>
        </p:txBody>
      </p:sp>
      <p:pic>
        <p:nvPicPr>
          <p:cNvPr id="12" name="Picture 11" descr="A picture containing grass, photo, sitting, old&#10;&#10;Description automatically generated">
            <a:extLst>
              <a:ext uri="{FF2B5EF4-FFF2-40B4-BE49-F238E27FC236}">
                <a16:creationId xmlns:a16="http://schemas.microsoft.com/office/drawing/2014/main" id="{EC4D9CC3-DB81-435D-93A2-FC095B4C205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7243" y="956891"/>
            <a:ext cx="2127600" cy="1399736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6FE093F1-D900-4B15-B214-C8F9A13E2367}"/>
              </a:ext>
            </a:extLst>
          </p:cNvPr>
          <p:cNvCxnSpPr>
            <a:cxnSpLocks/>
          </p:cNvCxnSpPr>
          <p:nvPr/>
        </p:nvCxnSpPr>
        <p:spPr>
          <a:xfrm>
            <a:off x="1462497" y="1096194"/>
            <a:ext cx="108672" cy="237600"/>
          </a:xfrm>
          <a:prstGeom prst="straightConnector1">
            <a:avLst/>
          </a:prstGeom>
          <a:ln w="9525">
            <a:solidFill>
              <a:schemeClr val="tx1"/>
            </a:solidFill>
            <a:tailEnd type="stealth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4AF4710D-FFAB-4592-80ED-01938EF388AF}"/>
              </a:ext>
            </a:extLst>
          </p:cNvPr>
          <p:cNvCxnSpPr>
            <a:cxnSpLocks/>
          </p:cNvCxnSpPr>
          <p:nvPr/>
        </p:nvCxnSpPr>
        <p:spPr>
          <a:xfrm flipH="1">
            <a:off x="930342" y="1193878"/>
            <a:ext cx="87165" cy="235945"/>
          </a:xfrm>
          <a:prstGeom prst="straightConnector1">
            <a:avLst/>
          </a:prstGeom>
          <a:ln w="9525">
            <a:solidFill>
              <a:schemeClr val="tx1"/>
            </a:solidFill>
            <a:tailEnd type="stealth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0036A5F6-8C84-43C7-B3DA-D22878372B13}"/>
              </a:ext>
            </a:extLst>
          </p:cNvPr>
          <p:cNvCxnSpPr>
            <a:cxnSpLocks/>
          </p:cNvCxnSpPr>
          <p:nvPr/>
        </p:nvCxnSpPr>
        <p:spPr>
          <a:xfrm>
            <a:off x="1217332" y="1169081"/>
            <a:ext cx="108672" cy="237600"/>
          </a:xfrm>
          <a:prstGeom prst="straightConnector1">
            <a:avLst/>
          </a:prstGeom>
          <a:ln w="9525">
            <a:solidFill>
              <a:schemeClr val="tx1"/>
            </a:solidFill>
            <a:tailEnd type="stealth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674268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5</TotalTime>
  <Words>298</Words>
  <Application>Microsoft Macintosh PowerPoint</Application>
  <PresentationFormat>A4 Paper (210x297 mm)</PresentationFormat>
  <Paragraphs>1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un Sandow</dc:creator>
  <cp:lastModifiedBy>Microsoft Office User</cp:lastModifiedBy>
  <cp:revision>24</cp:revision>
  <dcterms:created xsi:type="dcterms:W3CDTF">2020-08-23T05:35:23Z</dcterms:created>
  <dcterms:modified xsi:type="dcterms:W3CDTF">2020-11-23T22:38:15Z</dcterms:modified>
</cp:coreProperties>
</file>